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6858000" cy="9903460" type="A4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19" userDrawn="1">
          <p15:clr>
            <a:srgbClr val="A4A3A4"/>
          </p15:clr>
        </p15:guide>
        <p15:guide id="2" pos="213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2" name="作者" initials="A" lastIdx="0" clrIdx="1"/>
  <p:cmAuthor id="1" name="Administrator" initials="A" lastIdx="1" clrIdx="0"/>
  <p:cmAuthor id="3" name="lenovo" initials="l" lastIdx="6" clrIdx="2"/>
  <p:cmAuthor id="4" name="王习习" initials="王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3119"/>
        <p:guide pos="2132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63.xml"/><Relationship Id="rId7" Type="http://schemas.openxmlformats.org/officeDocument/2006/relationships/commentAuthors" Target="commentAuthors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674325" y="1320480"/>
            <a:ext cx="5512050" cy="3711901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674325" y="5141554"/>
            <a:ext cx="5512050" cy="2126285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342225" y="1117729"/>
            <a:ext cx="6172200" cy="791768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674325" y="3587131"/>
            <a:ext cx="5512050" cy="1471243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674325" y="5141554"/>
            <a:ext cx="5512050" cy="681035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342225" y="2152278"/>
            <a:ext cx="6170175" cy="6872735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119825" y="5557453"/>
            <a:ext cx="4369950" cy="1107332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119825" y="6664785"/>
            <a:ext cx="4369950" cy="1252896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35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342225" y="2167875"/>
            <a:ext cx="2911950" cy="6857138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606525" y="2167875"/>
            <a:ext cx="2911950" cy="6857138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342225" y="2063900"/>
            <a:ext cx="3005100" cy="551066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42225" y="2677351"/>
            <a:ext cx="3005100" cy="6347662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3507609" y="2053111"/>
            <a:ext cx="3005100" cy="551066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3507609" y="2677351"/>
            <a:ext cx="3005100" cy="6347662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342225" y="2245856"/>
            <a:ext cx="2943606" cy="6654388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3572100" y="2245856"/>
            <a:ext cx="2940300" cy="6654388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5757075" y="1320480"/>
            <a:ext cx="587250" cy="726264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1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514350" y="1320480"/>
            <a:ext cx="5157675" cy="7262640"/>
          </a:xfrm>
        </p:spPr>
        <p:txBody>
          <a:bodyPr vert="eaVert" lIns="46800" tIns="46800" rIns="46800" bIns="46800"/>
          <a:lstStyle>
            <a:lvl1pPr marL="171450" indent="-171450">
              <a:spcAft>
                <a:spcPts val="1000"/>
              </a:spcAft>
              <a:defRPr spc="300"/>
            </a:lvl1pPr>
            <a:lvl2pPr marL="514350" indent="-171450">
              <a:defRPr spc="300"/>
            </a:lvl2pPr>
            <a:lvl3pPr marL="857250" indent="-171450">
              <a:defRPr spc="300"/>
            </a:lvl3pPr>
            <a:lvl4pPr marL="1200150" indent="-171450">
              <a:defRPr spc="300"/>
            </a:lvl4pPr>
            <a:lvl5pPr marL="1543050" indent="-17145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342225" y="878587"/>
            <a:ext cx="6170175" cy="1018953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342225" y="2152278"/>
            <a:ext cx="6170175" cy="6872735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344250" y="9118590"/>
            <a:ext cx="151875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2315250" y="9118590"/>
            <a:ext cx="222750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4993650" y="9118590"/>
            <a:ext cx="151875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0" y="0"/>
            <a:ext cx="6272530" cy="245110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000" b="1">
                <a:latin typeface="Times New Roman" panose="02020603050405020304"/>
                <a:ea typeface="宋体" panose="02010600030101010101" pitchFamily="2" charset="-122"/>
              </a:rPr>
              <a:t>Supplementary Table 1 The primer sequences of YTHDF1, EEF1G, ERBB2, FBXO32, β-actin.</a:t>
            </a:r>
            <a:endParaRPr lang="en-US" altLang="zh-CN" sz="1000" b="1">
              <a:latin typeface="Times New Roman" panose="02020603050405020304"/>
              <a:ea typeface="宋体" panose="02010600030101010101" pitchFamily="2" charset="-122"/>
            </a:endParaRPr>
          </a:p>
        </p:txBody>
      </p:sp>
      <p:graphicFrame>
        <p:nvGraphicFramePr>
          <p:cNvPr id="7" name="表格 6"/>
          <p:cNvGraphicFramePr/>
          <p:nvPr/>
        </p:nvGraphicFramePr>
        <p:xfrm>
          <a:off x="298450" y="408525"/>
          <a:ext cx="6172200" cy="1226820"/>
        </p:xfrm>
        <a:graphic>
          <a:graphicData uri="http://schemas.openxmlformats.org/drawingml/2006/table">
            <a:tbl>
              <a:tblPr/>
              <a:tblGrid>
                <a:gridCol w="1412240"/>
                <a:gridCol w="2372360"/>
                <a:gridCol w="2387600"/>
              </a:tblGrid>
              <a:tr h="180340">
                <a:tc>
                  <a:txBody>
                    <a:bodyPr/>
                    <a:p>
                      <a:pPr algn="ctr" fontAlgn="ctr"/>
                      <a:r>
                        <a:rPr lang="en-US" altLang="zh-CN" sz="1000" b="1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rimers</a:t>
                      </a:r>
                      <a:endParaRPr lang="en-US" altLang="zh-CN" sz="1000" b="1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1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Forward primers 5’-3’</a:t>
                      </a:r>
                      <a:endParaRPr lang="en-US" altLang="zh-CN" sz="1000" b="1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1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Reverse primers 5’-3’</a:t>
                      </a:r>
                      <a:endParaRPr lang="en-US" altLang="zh-CN" sz="1000" b="1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0340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YTHDF1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ATACCTCACCACCTACGGACA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GTGCTGATAGATGTTGTTCCCC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0340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EEF1G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AACCGTTGCACCCCTGAATTTCTC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GGCGTTGCTCTCAAACACAC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0340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ERBB2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TGCAGGGAAACCTGGAACTC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ACAGGGGTGGTATTGTTCAGC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4470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FBXO32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GCCTTTGTGCCTACAACTGAA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CTGCCCTTTGTCTGACAGAAT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4470">
                <a:tc>
                  <a:txBody>
                    <a:bodyPr/>
                    <a:p>
                      <a:pPr algn="ctr" fontAlgn="ctr">
                        <a:buNone/>
                      </a:pPr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β-actin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>
                        <a:buNone/>
                      </a:pPr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GAGTCAACGGATTTGGTCGT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>
                        <a:buNone/>
                      </a:pPr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CATGGGTGGAATCATATTGGA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commondata" val="eyJoZGlkIjoiNjJiY2FjN2Q1OTQ0Zjc4MjEzOGFhOGE2OWY4ZjhkM2EifQ==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3</Words>
  <Application>WPS 演示</Application>
  <PresentationFormat>宽屏</PresentationFormat>
  <Paragraphs>38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Midsumner</cp:lastModifiedBy>
  <cp:revision>156</cp:revision>
  <dcterms:created xsi:type="dcterms:W3CDTF">2019-06-19T02:08:00Z</dcterms:created>
  <dcterms:modified xsi:type="dcterms:W3CDTF">2024-09-12T12:33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8240</vt:lpwstr>
  </property>
  <property fmtid="{D5CDD505-2E9C-101B-9397-08002B2CF9AE}" pid="3" name="ICV">
    <vt:lpwstr>D48A7DF49EC64DA4B217E011010980EF_11</vt:lpwstr>
  </property>
</Properties>
</file>